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2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636"/>
    <p:restoredTop sz="96466"/>
  </p:normalViewPr>
  <p:slideViewPr>
    <p:cSldViewPr snapToGrid="0" snapToObjects="1">
      <p:cViewPr varScale="1">
        <p:scale>
          <a:sx n="160" d="100"/>
          <a:sy n="160" d="100"/>
        </p:scale>
        <p:origin x="168" y="34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79B74B-81DA-1E4A-8C6E-C54F5106C642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70C003-AECD-FB43-B893-604E3282A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973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9517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8296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118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583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733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6887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966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898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448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43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427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60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3D1CD78-22D3-DA42-A9B3-D9E9F045A06F}"/>
              </a:ext>
            </a:extLst>
          </p:cNvPr>
          <p:cNvSpPr txBox="1"/>
          <p:nvPr/>
        </p:nvSpPr>
        <p:spPr>
          <a:xfrm>
            <a:off x="1562810" y="1883380"/>
            <a:ext cx="4495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S3 Table. Primers used to produce </a:t>
            </a:r>
            <a:r>
              <a:rPr lang="en-US" altLang="ja-JP" sz="1200" b="1" i="1" dirty="0"/>
              <a:t>in situ</a:t>
            </a:r>
            <a:r>
              <a:rPr lang="en-US" altLang="ja-JP" sz="1200" b="1" dirty="0"/>
              <a:t> hybridization probes.</a:t>
            </a:r>
            <a:endParaRPr lang="ja-JP" altLang="ja-JP" sz="1200"/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A4663AE5-911D-394B-A009-07E1733457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1903712"/>
              </p:ext>
            </p:extLst>
          </p:nvPr>
        </p:nvGraphicFramePr>
        <p:xfrm>
          <a:off x="1562810" y="2263986"/>
          <a:ext cx="5935270" cy="204893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07110">
                  <a:extLst>
                    <a:ext uri="{9D8B030D-6E8A-4147-A177-3AD203B41FA5}">
                      <a16:colId xmlns:a16="http://schemas.microsoft.com/office/drawing/2014/main" val="2227698734"/>
                    </a:ext>
                  </a:extLst>
                </a:gridCol>
                <a:gridCol w="2164080">
                  <a:extLst>
                    <a:ext uri="{9D8B030D-6E8A-4147-A177-3AD203B41FA5}">
                      <a16:colId xmlns:a16="http://schemas.microsoft.com/office/drawing/2014/main" val="1508856502"/>
                    </a:ext>
                  </a:extLst>
                </a:gridCol>
                <a:gridCol w="2164080">
                  <a:extLst>
                    <a:ext uri="{9D8B030D-6E8A-4147-A177-3AD203B41FA5}">
                      <a16:colId xmlns:a16="http://schemas.microsoft.com/office/drawing/2014/main" val="232967609"/>
                    </a:ext>
                  </a:extLst>
                </a:gridCol>
              </a:tblGrid>
              <a:tr h="28972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+mn-lt"/>
                        </a:rPr>
                        <a:t>Gene</a:t>
                      </a:r>
                      <a:endParaRPr kumimoji="1" lang="ja-JP" altLang="en-US" sz="100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Forward primer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Reverse primer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3456750"/>
                  </a:ext>
                </a:extLst>
              </a:tr>
              <a:tr h="293201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HvH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AGACAAAGTCAACCTCACCG</a:t>
                      </a:r>
                      <a:endParaRPr 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TGCAGTCCATTCGATTCCAC</a:t>
                      </a:r>
                      <a:endParaRPr lang="ja-JP" sz="1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5400763"/>
                  </a:ext>
                </a:extLst>
              </a:tr>
              <a:tr h="2932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MND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TGGCCATCGAGAGCAGCAAC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CATTCTGCCATGTATGCACC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00307014"/>
                  </a:ext>
                </a:extLst>
              </a:tr>
              <a:tr h="2932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MND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GTGGACGAAGGCTACGACC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GGCAAAAACATCACGGTCG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18941954"/>
                  </a:ext>
                </a:extLst>
              </a:tr>
              <a:tr h="293201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MND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CAGTGGGTGTCGTTGTTCAC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GGCTAGCTAG CTTTGGCTT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0411700"/>
                  </a:ext>
                </a:extLst>
              </a:tr>
              <a:tr h="293201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OsBE1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GCTCCAGGCGAAGAAGCA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TACATCAGGCTGGTGGTCTGG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6707863"/>
                  </a:ext>
                </a:extLst>
              </a:tr>
              <a:tr h="293201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OsGNAT1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TTCGGGTACGCGCCGTTCAG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TTGGCAGAGATGGTGGGTG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69869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36750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1</TotalTime>
  <Words>36</Words>
  <Application>Microsoft Macintosh PowerPoint</Application>
  <PresentationFormat>A4 210 x 297 mm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Microsoft Office ユーザー</dc:creator>
  <cp:keywords/>
  <dc:description/>
  <cp:lastModifiedBy>Microsoft Office ユーザー</cp:lastModifiedBy>
  <cp:revision>179</cp:revision>
  <cp:lastPrinted>2019-06-06T02:25:27Z</cp:lastPrinted>
  <dcterms:created xsi:type="dcterms:W3CDTF">2019-05-23T03:32:55Z</dcterms:created>
  <dcterms:modified xsi:type="dcterms:W3CDTF">2021-04-14T08:33:25Z</dcterms:modified>
  <cp:category/>
</cp:coreProperties>
</file>